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6"/>
  </p:notesMasterIdLst>
  <p:sldIdLst>
    <p:sldId id="320" r:id="rId3"/>
    <p:sldId id="315" r:id="rId4"/>
    <p:sldId id="319" r:id="rId5"/>
  </p:sldIdLst>
  <p:sldSz cx="9144000" cy="6858000" type="screen4x3"/>
  <p:notesSz cx="6858000" cy="9144000"/>
  <p:defaultTextStyle>
    <a:defPPr>
      <a:defRPr lang="ru-R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1114" y="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6B5570C-591D-4CF2-A606-24A35BD5A900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ru-RU" noProof="0" smtClean="0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noProof="0" smtClean="0"/>
              <a:t>Образец текста</a:t>
            </a:r>
          </a:p>
          <a:p>
            <a:pPr lvl="1"/>
            <a:r>
              <a:rPr lang="ru-RU" noProof="0" smtClean="0"/>
              <a:t>Второй уровень</a:t>
            </a:r>
          </a:p>
          <a:p>
            <a:pPr lvl="2"/>
            <a:r>
              <a:rPr lang="ru-RU" noProof="0" smtClean="0"/>
              <a:t>Третий уровень</a:t>
            </a:r>
          </a:p>
          <a:p>
            <a:pPr lvl="3"/>
            <a:r>
              <a:rPr lang="ru-RU" noProof="0" smtClean="0"/>
              <a:t>Четвертый уровень</a:t>
            </a:r>
          </a:p>
          <a:p>
            <a:pPr lvl="4"/>
            <a:r>
              <a:rPr lang="ru-RU" noProof="0" smtClean="0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96DD207E-0E97-4C79-B086-7B7893290FE0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1424330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7171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ru-RU" altLang="ru-RU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2FB3C1-2467-462D-AFF2-876B93CA5BDE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28211B-94E8-4DEE-AE2A-1498C5F0E347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18884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CFEC4D-7B52-416C-96E3-2AAF0402F34E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4B48D1-9D88-4D7E-B1C5-655F859E2816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87730325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A376F1-56C0-4C3D-ABD9-00C201FE5A60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EC4328-6B2F-4F71-83C0-B04AD770C45A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40243091"/>
      </p:ext>
    </p:extLst>
  </p:cSld>
  <p:clrMapOvr>
    <a:masterClrMapping/>
  </p:clrMapOvr>
  <p:transition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E637DF-3086-44CC-9449-FF0C23ACB4B0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8E1AA1-B558-41EE-84EE-E4D566C79CE8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308907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546F0C-BCF3-465B-A59C-13CE78880856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FBC936-64F0-49F8-AFE8-402F10BD8B94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775831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548E39-172F-40D3-B40B-0C21619FE751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733B81-4AE2-4B93-9181-518588F84C18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0654551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BA17F6-FD47-4815-828B-6A1640A7A1BF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AAE0DB-D568-4B87-8BE7-64D9D89AB808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2721419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C6BEE9-7711-4579-85AA-247A95D7C773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8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9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8DBC4A-F9B5-4484-8C4B-B7E7D5972B98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449957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378D32-FB83-448F-B67F-21083A8271C2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4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5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9945C7-093C-4DC8-ABC2-A9F7EEC96FE3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0666681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B1002B-A9CA-4DE1-8D3B-44633BAB6BCE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3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4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5E23DF-3282-48B1-9039-952C7F2BCBC3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557688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9B4FBD-B2BF-461E-9267-7B351955A88F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BFCE8E-2983-4BC0-9E02-4CDD5351763F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1411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7A3C0F-F5C0-432D-B533-1E35ADFC02CC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A4D088-3300-4D3C-ADAA-5BB7A8F53871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99470710"/>
      </p:ext>
    </p:extLst>
  </p:cSld>
  <p:clrMapOvr>
    <a:masterClrMapping/>
  </p:clrMapOvr>
  <p:transition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ru-RU" noProof="0" smtClean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A9E094-D83B-4DFC-8C37-0BF328B56185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7F8013-8A63-48E5-9FD6-5B7142AAD754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830055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BE5789-127E-42EA-9D92-4C4C9C8787EC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BD94D4-3550-4A7D-B76D-81BACACCCDC9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8769314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A158D6-C7D3-471A-B4E6-4FE13164C420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6A8D1-AEAF-4EF1-9A36-1EFA7EB8A963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96638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DDD93-653A-4EE2-B97E-8BF02477BDA8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EAB937-621E-419A-ACDC-73FC8BDB3F7A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81142379"/>
      </p:ext>
    </p:extLst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9F35C2-F41C-4A53-8DB8-DA369C07350C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8F5F20-962C-45F7-A45F-C7246BE3421B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15668574"/>
      </p:ext>
    </p:extLst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3F421F-4794-4F6D-8E51-3FA231514A9D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8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9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C87048-F75D-4E0A-93A5-330370D8CE61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97902221"/>
      </p:ext>
    </p:extLst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F80877-FB82-490A-8156-0014B9772EE7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4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5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63FFFF-6EE9-4455-B641-8D014854BAE6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14467995"/>
      </p:ext>
    </p:extLst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CD6769-A333-45A5-AD7F-015496FC3CCE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3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4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2117F1-B6A3-46FF-A732-F3D0D630458C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30858157"/>
      </p:ext>
    </p:extLst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A060BA-A8B4-49C0-AFF1-039435C4973F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9A3C36-7694-41D7-93B3-A471454057DE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6581934"/>
      </p:ext>
    </p:extLst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ru-RU" noProof="0" smtClean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90482-18AE-4CFF-916C-944B1E876299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6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C60499-91AB-4B98-B256-458C711A6581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73564078"/>
      </p:ext>
    </p:extLst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Заголовок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заголовка</a:t>
            </a:r>
          </a:p>
        </p:txBody>
      </p:sp>
      <p:sp>
        <p:nvSpPr>
          <p:cNvPr id="1027" name="Текст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текста</a:t>
            </a:r>
          </a:p>
          <a:p>
            <a:pPr lvl="1"/>
            <a:r>
              <a:rPr lang="ru-RU" altLang="ru-RU" smtClean="0"/>
              <a:t>Второй уровень</a:t>
            </a:r>
          </a:p>
          <a:p>
            <a:pPr lvl="2"/>
            <a:r>
              <a:rPr lang="ru-RU" altLang="ru-RU" smtClean="0"/>
              <a:t>Третий уровень</a:t>
            </a:r>
          </a:p>
          <a:p>
            <a:pPr lvl="3"/>
            <a:r>
              <a:rPr lang="ru-RU" altLang="ru-RU" smtClean="0"/>
              <a:t>Четвертый уровень</a:t>
            </a:r>
          </a:p>
          <a:p>
            <a:pPr lvl="4"/>
            <a:r>
              <a:rPr lang="ru-RU" altLang="ru-RU" smtClean="0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DAE66C4-98CA-485A-A1FE-FA72F6D5043E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33C3390-DDB5-4E34-9349-B567294A9621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ransition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rgbClr val="9AB5E4"/>
            </a:gs>
            <a:gs pos="50000">
              <a:srgbClr val="C2D1ED"/>
            </a:gs>
            <a:gs pos="100000">
              <a:srgbClr val="E1E8F5"/>
            </a:gs>
          </a:gsLst>
          <a:lin ang="54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Заголовок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заголовка</a:t>
            </a:r>
          </a:p>
        </p:txBody>
      </p:sp>
      <p:sp>
        <p:nvSpPr>
          <p:cNvPr id="2051" name="Текст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текста</a:t>
            </a:r>
          </a:p>
          <a:p>
            <a:pPr lvl="1"/>
            <a:r>
              <a:rPr lang="ru-RU" altLang="ru-RU" smtClean="0"/>
              <a:t>Второй уровень</a:t>
            </a:r>
          </a:p>
          <a:p>
            <a:pPr lvl="2"/>
            <a:r>
              <a:rPr lang="ru-RU" altLang="ru-RU" smtClean="0"/>
              <a:t>Третий уровень</a:t>
            </a:r>
          </a:p>
          <a:p>
            <a:pPr lvl="3"/>
            <a:r>
              <a:rPr lang="ru-RU" altLang="ru-RU" smtClean="0"/>
              <a:t>Четвертый уровень</a:t>
            </a:r>
          </a:p>
          <a:p>
            <a:pPr lvl="4"/>
            <a:r>
              <a:rPr lang="ru-RU" altLang="ru-RU" smtClean="0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05259A17-43DC-4469-8007-A2DD84EDB48D}" type="datetimeFigureOut">
              <a:rPr lang="ru-RU"/>
              <a:pPr>
                <a:defRPr/>
              </a:pPr>
              <a:t>22.01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223270A-0664-4FD6-8C40-8F0A4D56C10B}" type="slidenum">
              <a:rPr lang="ru-RU"/>
              <a:pPr>
                <a:defRPr/>
              </a:pPr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90" r:id="rId7"/>
    <p:sldLayoutId id="2147483691" r:id="rId8"/>
    <p:sldLayoutId id="2147483692" r:id="rId9"/>
    <p:sldLayoutId id="2147483693" r:id="rId10"/>
    <p:sldLayoutId id="21474836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2276475"/>
            <a:ext cx="9072563" cy="23083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Gif-animation </a:t>
            </a:r>
            <a:r>
              <a:rPr lang="en-US" sz="3600" b="1" dirty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f depth profiles dynamics of air and blood content in lungs in processes of breathing and heart </a:t>
            </a:r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beating</a:t>
            </a:r>
          </a:p>
          <a:p>
            <a:pPr algn="ctr"/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3600" b="1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sie</a:t>
            </a:r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in slide-show mode)</a:t>
            </a:r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36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Рисунок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813" y="1339850"/>
            <a:ext cx="5688012" cy="437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99" name="Rectangle 2"/>
          <p:cNvSpPr>
            <a:spLocks noChangeArrowheads="1"/>
          </p:cNvSpPr>
          <p:nvPr/>
        </p:nvSpPr>
        <p:spPr bwMode="auto">
          <a:xfrm>
            <a:off x="179388" y="406400"/>
            <a:ext cx="9072562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Animation </a:t>
            </a:r>
            <a:r>
              <a:rPr lang="en-US" sz="3600" b="1" dirty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f air content dynamics</a:t>
            </a:r>
            <a:endParaRPr lang="en-US" sz="36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Рисунок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813" y="1341438"/>
            <a:ext cx="5688012" cy="4348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3" name="Rectangle 2"/>
          <p:cNvSpPr>
            <a:spLocks noChangeArrowheads="1"/>
          </p:cNvSpPr>
          <p:nvPr/>
        </p:nvSpPr>
        <p:spPr bwMode="auto">
          <a:xfrm>
            <a:off x="179388" y="406400"/>
            <a:ext cx="9072562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3600" b="1" dirty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3600" b="1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nimation </a:t>
            </a:r>
            <a:r>
              <a:rPr lang="en-US" sz="3600" b="1" dirty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f blood content dynamics</a:t>
            </a:r>
            <a:endParaRPr lang="en-US" sz="36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6</TotalTime>
  <Words>35</Words>
  <Application>Microsoft Office PowerPoint</Application>
  <PresentationFormat>Экран (4:3)</PresentationFormat>
  <Paragraphs>4</Paragraphs>
  <Slides>3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2</vt:i4>
      </vt:variant>
      <vt:variant>
        <vt:lpstr>Заголовки слайдов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 New Roman</vt:lpstr>
      <vt:lpstr>1_Тема Office</vt:lpstr>
      <vt:lpstr>Тема Office</vt:lpstr>
      <vt:lpstr>Презентация PowerPoint</vt:lpstr>
      <vt:lpstr>Презентация PowerPoint</vt:lpstr>
      <vt:lpstr>Презентация PowerPoint</vt:lpstr>
    </vt:vector>
  </TitlesOfParts>
  <Company>SPecialiST RePac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Gai</dc:creator>
  <cp:lastModifiedBy>Konstantin Gaikovich</cp:lastModifiedBy>
  <cp:revision>84</cp:revision>
  <dcterms:created xsi:type="dcterms:W3CDTF">2019-05-28T18:06:34Z</dcterms:created>
  <dcterms:modified xsi:type="dcterms:W3CDTF">2023-01-22T08:19:43Z</dcterms:modified>
</cp:coreProperties>
</file>